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6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368" autoAdjust="0"/>
    <p:restoredTop sz="94660"/>
  </p:normalViewPr>
  <p:slideViewPr>
    <p:cSldViewPr snapToGrid="0">
      <p:cViewPr varScale="1">
        <p:scale>
          <a:sx n="82" d="100"/>
          <a:sy n="82" d="100"/>
        </p:scale>
        <p:origin x="749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EF90402-2EBC-4890-BA9C-730378ACC1C8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C996A1-3325-4BCE-A676-9EEF10B28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19691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4EE58D-20DE-ECC9-9695-23C04B7444F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906A722-11B5-073B-A8F0-E4FB505A308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85DABC-0C06-D38F-DC01-45B16D569B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64F73-B359-4BDA-9989-674D9960CBF9}" type="datetimeFigureOut">
              <a:rPr lang="en-GB" smtClean="0"/>
              <a:t>21/01/2024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27068F-CC0F-817E-2E43-2658B3A2E5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9DD98F-9E8B-64D2-0A55-18C38B84E7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A64-CBE1-4C1C-BAD2-7C3214BFDA6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701292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EEB4BF-E0B5-DD0A-271A-386680E9A5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6F28987-5661-1FB0-07CE-53B3372FE0B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3E4EBE-174D-DB16-90E2-F3880337DC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64F73-B359-4BDA-9989-674D9960CBF9}" type="datetimeFigureOut">
              <a:rPr lang="en-GB" smtClean="0"/>
              <a:t>21/01/2024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E6B920-EA89-98D3-E626-955CBB5BFF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51F7A3-2A95-926D-2040-B8E33B4443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A64-CBE1-4C1C-BAD2-7C3214BFDA6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200702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6A7C243-C0A2-5A53-8A37-827EF0072D2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7B9EB2E-62D5-846C-D35D-B632A32A0B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6D2ED7-15AD-792F-B2F1-7F97C0F021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64F73-B359-4BDA-9989-674D9960CBF9}" type="datetimeFigureOut">
              <a:rPr lang="en-GB" smtClean="0"/>
              <a:t>21/01/2024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1C0536-D967-6D7D-67A8-80B61D063A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CC561B-C934-B863-4ADB-00DB6B31EE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A64-CBE1-4C1C-BAD2-7C3214BFDA6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350458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35DCD1-247E-8837-B4E7-85E531C406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140AACC-F8B2-2922-692A-20D7162D1D7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6D65DD-89C0-4AC6-2668-AFEF85A75D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64F73-B359-4BDA-9989-674D9960CBF9}" type="datetimeFigureOut">
              <a:rPr lang="en-GB" smtClean="0"/>
              <a:t>21/01/2024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6B7731-BAB6-6FFE-1F58-F48E87F08B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4F38BD-3EFA-CEF8-35D5-49FDEE8A3B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A64-CBE1-4C1C-BAD2-7C3214BFDA6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1124861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9F43DB-432D-8A34-79F4-9B0DEBD4F4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8486E7-7662-B4CD-72EB-570B1E0E69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6291A8-F581-287F-C333-C98069E711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64F73-B359-4BDA-9989-674D9960CBF9}" type="datetimeFigureOut">
              <a:rPr lang="en-GB" smtClean="0"/>
              <a:t>21/01/2024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716A75-58C4-500B-BC64-7A1919BAE9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722B72-D54F-EC9D-4196-DA6F602DD1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A64-CBE1-4C1C-BAD2-7C3214BFDA6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196691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01ED11-69D7-16AC-1CAE-B9B114963B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973E40F-EF8B-2B6C-B430-7B2646B7271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A68F6E7-1760-3428-AEC1-D23EA1F410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84E490-13D5-91EE-0FFF-F2D3FB46B1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64F73-B359-4BDA-9989-674D9960CBF9}" type="datetimeFigureOut">
              <a:rPr lang="en-GB" smtClean="0"/>
              <a:t>21/01/2024</a:t>
            </a:fld>
            <a:endParaRPr lang="en-GB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7DE415-DC13-E2C2-C756-4362597CF0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755801C-B116-2D68-006B-C706AC2BDC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A64-CBE1-4C1C-BAD2-7C3214BFDA6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775271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7FE10E-F244-AAF7-488F-B3D47C2104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F5D652-EC7B-E576-08B4-29E85E92CE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C105A59-9878-8054-04BB-C689F24C14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EC03569-C66E-C2C6-912E-CAFD3F0CE1A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C717DF2-1B06-85CB-F29B-9C27A099CA2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266A0E9-C908-20E5-18DC-6CF854FB8D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64F73-B359-4BDA-9989-674D9960CBF9}" type="datetimeFigureOut">
              <a:rPr lang="en-GB" smtClean="0"/>
              <a:t>21/01/2024</a:t>
            </a:fld>
            <a:endParaRPr lang="en-GB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2DE9FF2-3C39-6764-7951-48D8B56ECC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04A9A1A-84CC-92F0-0C08-9EE09878D1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A64-CBE1-4C1C-BAD2-7C3214BFDA6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4088071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98FFB1-E4A3-4B9B-CAC7-A71D3EF4DF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0291592-63F3-9979-238C-388D97FD68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64F73-B359-4BDA-9989-674D9960CBF9}" type="datetimeFigureOut">
              <a:rPr lang="en-GB" smtClean="0"/>
              <a:t>21/01/2024</a:t>
            </a:fld>
            <a:endParaRPr lang="en-GB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EAF3501-3EA3-88B7-1541-6149DF198A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42ED5A6-4407-E340-78AB-8B17396F87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A64-CBE1-4C1C-BAD2-7C3214BFDA6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10093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42D4757-B42F-79B1-2C84-8768260B6C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64F73-B359-4BDA-9989-674D9960CBF9}" type="datetimeFigureOut">
              <a:rPr lang="en-GB" smtClean="0"/>
              <a:t>21/01/2024</a:t>
            </a:fld>
            <a:endParaRPr lang="en-GB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0853429-6855-0929-4D20-B773BD18AC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28B0803-70FA-6D10-95E8-BC0335F21D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A64-CBE1-4C1C-BAD2-7C3214BFDA6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635713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42237A-53D8-06A8-EE57-1472F538F6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E19037-9D98-8DAD-BC61-D06D7026EF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7DAA905-AEB1-7C74-34E3-EAAC4DEE60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B42194-5987-442B-1764-E5E2F82BDF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64F73-B359-4BDA-9989-674D9960CBF9}" type="datetimeFigureOut">
              <a:rPr lang="en-GB" smtClean="0"/>
              <a:t>21/01/2024</a:t>
            </a:fld>
            <a:endParaRPr lang="en-GB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2CC79AD-B791-8A85-4E8A-E56935252F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D3AAEF-210F-F8DD-E7C1-595DBDDF02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A64-CBE1-4C1C-BAD2-7C3214BFDA6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796961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7B59C6-ECB3-0E4C-A519-82F328BDD8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7EE8F61-9834-4A38-8160-DDC130C7F36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EE1B649-AA48-3A34-E9AC-0A67A44C98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D9E41D-FF98-6002-DE41-4D3C66E2E9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264F73-B359-4BDA-9989-674D9960CBF9}" type="datetimeFigureOut">
              <a:rPr lang="en-GB" smtClean="0"/>
              <a:t>21/01/2024</a:t>
            </a:fld>
            <a:endParaRPr lang="en-GB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A303D37-50A4-9EE1-EFEF-900F6379C7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362918A-DC51-76B6-9AF5-DC59E48A74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A64-CBE1-4C1C-BAD2-7C3214BFDA6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6501738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E3593D5-6C17-E8AA-6CD2-4D2891E142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817A2D-DA74-0865-252E-5405684F1E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D8F7F8-4C81-F060-D4D2-014C0532C00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264F73-B359-4BDA-9989-674D9960CBF9}" type="datetimeFigureOut">
              <a:rPr lang="en-GB" smtClean="0"/>
              <a:t>21/01/2024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C764F5-5DA8-F300-9A30-7C6DBEF2324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A8F997-FF39-B6B5-0165-5F383EBA39D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34EA64-CBE1-4C1C-BAD2-7C3214BFDA6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1510106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E3B6ECFF-BE59-D19E-88B6-B70969EAEC3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98554318"/>
              </p:ext>
            </p:extLst>
          </p:nvPr>
        </p:nvGraphicFramePr>
        <p:xfrm>
          <a:off x="386148" y="1755555"/>
          <a:ext cx="11589952" cy="4010029"/>
        </p:xfrm>
        <a:graphic>
          <a:graphicData uri="http://schemas.openxmlformats.org/drawingml/2006/table">
            <a:tbl>
              <a:tblPr firstRow="1" firstCol="1" bandRow="1"/>
              <a:tblGrid>
                <a:gridCol w="1303161">
                  <a:extLst>
                    <a:ext uri="{9D8B030D-6E8A-4147-A177-3AD203B41FA5}">
                      <a16:colId xmlns:a16="http://schemas.microsoft.com/office/drawing/2014/main" val="661650732"/>
                    </a:ext>
                  </a:extLst>
                </a:gridCol>
                <a:gridCol w="1505942">
                  <a:extLst>
                    <a:ext uri="{9D8B030D-6E8A-4147-A177-3AD203B41FA5}">
                      <a16:colId xmlns:a16="http://schemas.microsoft.com/office/drawing/2014/main" val="119336461"/>
                    </a:ext>
                  </a:extLst>
                </a:gridCol>
                <a:gridCol w="4898882">
                  <a:extLst>
                    <a:ext uri="{9D8B030D-6E8A-4147-A177-3AD203B41FA5}">
                      <a16:colId xmlns:a16="http://schemas.microsoft.com/office/drawing/2014/main" val="658352967"/>
                    </a:ext>
                  </a:extLst>
                </a:gridCol>
                <a:gridCol w="190782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97414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252095">
                <a:tc>
                  <a:txBody>
                    <a:bodyPr/>
                    <a:lstStyle/>
                    <a:p>
                      <a:pPr algn="l"/>
                      <a:r>
                        <a:rPr lang="en-US" sz="2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Primer set</a:t>
                      </a:r>
                      <a:endParaRPr lang="ja-JP" sz="20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Primer</a:t>
                      </a:r>
                      <a:endParaRPr lang="ja-JP" sz="20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Sequence</a:t>
                      </a:r>
                      <a:endParaRPr lang="ja-JP" sz="20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2000" kern="100" dirty="0"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nt position</a:t>
                      </a:r>
                      <a:endParaRPr lang="ja-JP" sz="2000" kern="100" dirty="0"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2000" kern="100" dirty="0"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Size</a:t>
                      </a:r>
                      <a:endParaRPr lang="ja-JP" sz="2000" kern="100" dirty="0"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1759723"/>
                  </a:ext>
                </a:extLst>
              </a:tr>
              <a:tr h="461963">
                <a:tc rowSpan="2">
                  <a:txBody>
                    <a:bodyPr/>
                    <a:lstStyle/>
                    <a:p>
                      <a:pPr algn="ctr"/>
                      <a:r>
                        <a:rPr lang="en-US" sz="2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Bovine Rotavirus VP6</a:t>
                      </a:r>
                      <a:endParaRPr lang="ja-JP" sz="20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Forward</a:t>
                      </a:r>
                      <a:endParaRPr lang="ja-JP" sz="20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’- ATGGATGTCCTGTACTCCTTG -3’</a:t>
                      </a:r>
                      <a:endParaRPr lang="ja-JP" sz="20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/>
                      <a:r>
                        <a:rPr lang="en-US" altLang="ja-JP" sz="20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6154</a:t>
                      </a:r>
                      <a:r>
                        <a:rPr lang="ja-JP" altLang="en-US" sz="20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20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- 7344</a:t>
                      </a:r>
                      <a:endParaRPr lang="ja-JP" sz="20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/>
                      <a:r>
                        <a:rPr lang="en-US" altLang="ja-JP" sz="2000" kern="100" dirty="0"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1194 bp</a:t>
                      </a:r>
                      <a:endParaRPr lang="ja-JP" sz="2000" kern="100" dirty="0"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6879893"/>
                  </a:ext>
                </a:extLst>
              </a:tr>
              <a:tr h="46196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Reverse</a:t>
                      </a:r>
                      <a:endParaRPr lang="ja-JP" sz="20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’- TCATTTGACAAGCATGCTTC -3’</a:t>
                      </a:r>
                      <a:endParaRPr lang="ja-JP" sz="20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ja-JP" sz="20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ja-JP" sz="20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5515671"/>
                  </a:ext>
                </a:extLst>
              </a:tr>
              <a:tr h="461963">
                <a:tc rowSpan="2">
                  <a:txBody>
                    <a:bodyPr/>
                    <a:lstStyle/>
                    <a:p>
                      <a:pPr algn="ctr"/>
                      <a:r>
                        <a:rPr lang="en-US" sz="2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Bovine Rotavirus VP4</a:t>
                      </a:r>
                      <a:endParaRPr lang="ja-JP" sz="20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Forward</a:t>
                      </a:r>
                      <a:endParaRPr lang="ja-JP" sz="20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2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’-</a:t>
                      </a:r>
                      <a:r>
                        <a:rPr lang="en-US" sz="20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2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ATGGCTTCACTCATTTATAGACAG -3’</a:t>
                      </a:r>
                      <a:endParaRPr lang="ja-JP" sz="20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/>
                      <a:r>
                        <a:rPr lang="en-US" altLang="ja-JP" sz="200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6154 - 8484</a:t>
                      </a:r>
                      <a:endParaRPr lang="ja-JP" sz="20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/>
                      <a:r>
                        <a:rPr lang="en-US" altLang="ja-JP" sz="2000" kern="100" dirty="0"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2331 bp</a:t>
                      </a:r>
                      <a:endParaRPr lang="ja-JP" sz="2000" kern="100" dirty="0"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1211204"/>
                  </a:ext>
                </a:extLst>
              </a:tr>
              <a:tr h="46196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Reverse</a:t>
                      </a:r>
                      <a:endParaRPr lang="ja-JP" sz="20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2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’-TTACAAGCGACATTGCATTATC-3’</a:t>
                      </a:r>
                      <a:endParaRPr lang="ja-JP" sz="20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just"/>
                      <a:endParaRPr lang="ja-JP" sz="20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just"/>
                      <a:endParaRPr lang="ja-JP" sz="20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42616535"/>
                  </a:ext>
                </a:extLst>
              </a:tr>
              <a:tr h="461963">
                <a:tc rowSpan="2">
                  <a:txBody>
                    <a:bodyPr/>
                    <a:lstStyle/>
                    <a:p>
                      <a:pPr algn="ctr"/>
                      <a:r>
                        <a:rPr lang="en-US" sz="2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APMV2 F + APMV2 HN</a:t>
                      </a:r>
                      <a:endParaRPr lang="ja-JP" sz="20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Forward</a:t>
                      </a:r>
                      <a:endParaRPr lang="ja-JP" sz="20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’-ACGACATTGGCTCCGTAACA-3’</a:t>
                      </a:r>
                      <a:endParaRPr lang="ja-JP" sz="20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2000" kern="100" dirty="0"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8678(+insert)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2000" kern="100" dirty="0"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 - 9613(+insert)</a:t>
                      </a: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/>
                      <a:r>
                        <a:rPr lang="en-US" altLang="ja-JP" sz="2000" kern="100" dirty="0"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936 bp</a:t>
                      </a:r>
                      <a:r>
                        <a:rPr lang="ja-JP" altLang="en-US" sz="2000" kern="100" baseline="0" dirty="0"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 </a:t>
                      </a:r>
                      <a:endParaRPr lang="ja-JP" sz="2000" kern="100" dirty="0"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8254217"/>
                  </a:ext>
                </a:extLst>
              </a:tr>
              <a:tr h="46196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Reverse</a:t>
                      </a:r>
                      <a:endParaRPr lang="ja-JP" sz="20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’-TGATGTCATCTGCAGAGGTA-3’</a:t>
                      </a:r>
                      <a:endParaRPr lang="ja-JP" sz="20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ja-JP" sz="20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ja-JP" sz="20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030540"/>
                  </a:ext>
                </a:extLst>
              </a:tr>
              <a:tr h="461963">
                <a:tc rowSpan="2">
                  <a:txBody>
                    <a:bodyPr/>
                    <a:lstStyle/>
                    <a:p>
                      <a:pPr algn="ctr"/>
                      <a:r>
                        <a:rPr lang="en-US" sz="2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NDV 6001 +</a:t>
                      </a:r>
                    </a:p>
                    <a:p>
                      <a:pPr algn="ctr"/>
                      <a:r>
                        <a:rPr lang="en-US" sz="2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NDV 6180</a:t>
                      </a:r>
                      <a:endParaRPr lang="ja-JP" sz="20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Forward</a:t>
                      </a:r>
                      <a:endParaRPr lang="ja-JP" sz="20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’-GAAAATCAAGCGCCTTGC-3’</a:t>
                      </a:r>
                      <a:endParaRPr lang="ja-JP" sz="20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/>
                      <a:r>
                        <a:rPr lang="en-US" altLang="ja-JP" sz="2000" kern="100" dirty="0"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6001 </a:t>
                      </a:r>
                    </a:p>
                    <a:p>
                      <a:pPr algn="l"/>
                      <a:r>
                        <a:rPr lang="en-US" altLang="ja-JP" sz="2000" kern="100" dirty="0"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- 6180(+insert)</a:t>
                      </a:r>
                      <a:endParaRPr lang="ja-JP" altLang="en-US" sz="2000" kern="100" dirty="0"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/>
                      <a:r>
                        <a:rPr lang="en-US" altLang="ja-JP" sz="2000" kern="100" dirty="0"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180 bp</a:t>
                      </a:r>
                      <a:r>
                        <a:rPr lang="ja-JP" altLang="en-US" sz="2000" kern="100" baseline="0" dirty="0"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2000" kern="100" dirty="0"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(+insert)</a:t>
                      </a:r>
                      <a:endParaRPr lang="ja-JP" sz="2000" kern="100" dirty="0"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6904314"/>
                  </a:ext>
                </a:extLst>
              </a:tr>
              <a:tr h="46196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Reverse</a:t>
                      </a:r>
                      <a:endParaRPr lang="ja-JP" sz="200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2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’-TCCTTAATGTAGCTAG-3’</a:t>
                      </a:r>
                      <a:endParaRPr lang="ja-JP" sz="20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r>
                        <a:rPr lang="en-US" altLang="ja-JP" sz="2000" kern="100" dirty="0"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- 6180</a:t>
                      </a:r>
                      <a:endParaRPr lang="ja-JP" sz="2000" kern="100" dirty="0"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ja-JP" sz="2000" kern="10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20320" marR="2032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194924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149765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74</TotalTime>
  <Words>102</Words>
  <Application>Microsoft Office PowerPoint</Application>
  <PresentationFormat>Widescreen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 Rofaida Mostafa</dc:creator>
  <cp:lastModifiedBy>Dr Rofaida Mostafa</cp:lastModifiedBy>
  <cp:revision>241</cp:revision>
  <dcterms:created xsi:type="dcterms:W3CDTF">2023-07-06T13:18:24Z</dcterms:created>
  <dcterms:modified xsi:type="dcterms:W3CDTF">2024-01-20T15:10:32Z</dcterms:modified>
</cp:coreProperties>
</file>